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541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84FD3EF-CBB9-4F00-A327-225C268D8CC3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A8D8AD-6D2D-4F8B-9B96-6077DA8C8DDB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3520D5-3E33-4496-BF5F-454D2A2E85F5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F048B-EE60-4EF8-8E26-5615A38D03D0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E898F-D5F4-4D2A-9997-D8A8AB90E22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F048B-EE60-4EF8-8E26-5615A38D03D0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E898F-D5F4-4D2A-9997-D8A8AB90E22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F048B-EE60-4EF8-8E26-5615A38D03D0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E898F-D5F4-4D2A-9997-D8A8AB90E22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F048B-EE60-4EF8-8E26-5615A38D03D0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E898F-D5F4-4D2A-9997-D8A8AB90E22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F048B-EE60-4EF8-8E26-5615A38D03D0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E898F-D5F4-4D2A-9997-D8A8AB90E22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F048B-EE60-4EF8-8E26-5615A38D03D0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E898F-D5F4-4D2A-9997-D8A8AB90E22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F048B-EE60-4EF8-8E26-5615A38D03D0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E898F-D5F4-4D2A-9997-D8A8AB90E22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F048B-EE60-4EF8-8E26-5615A38D03D0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E898F-D5F4-4D2A-9997-D8A8AB90E22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F048B-EE60-4EF8-8E26-5615A38D03D0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E898F-D5F4-4D2A-9997-D8A8AB90E22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F048B-EE60-4EF8-8E26-5615A38D03D0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E898F-D5F4-4D2A-9997-D8A8AB90E22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F048B-EE60-4EF8-8E26-5615A38D03D0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E898F-D5F4-4D2A-9997-D8A8AB90E22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8F048B-EE60-4EF8-8E26-5615A38D03D0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9E898F-D5F4-4D2A-9997-D8A8AB90E22D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119"/>
          <p:cNvGrpSpPr/>
          <p:nvPr/>
        </p:nvGrpSpPr>
        <p:grpSpPr>
          <a:xfrm>
            <a:off x="304800" y="609600"/>
            <a:ext cx="8534400" cy="6172200"/>
            <a:chOff x="180975" y="152400"/>
            <a:chExt cx="8658225" cy="6477000"/>
          </a:xfrm>
        </p:grpSpPr>
        <p:sp>
          <p:nvSpPr>
            <p:cNvPr id="7" name="Freeform 8"/>
            <p:cNvSpPr>
              <a:spLocks noEditPoints="1"/>
            </p:cNvSpPr>
            <p:nvPr/>
          </p:nvSpPr>
          <p:spPr bwMode="auto">
            <a:xfrm>
              <a:off x="1247150" y="587831"/>
              <a:ext cx="7360488" cy="1540943"/>
            </a:xfrm>
            <a:custGeom>
              <a:avLst/>
              <a:gdLst>
                <a:gd name="T0" fmla="*/ 0 w 10323"/>
                <a:gd name="T1" fmla="*/ 2004 h 2010"/>
                <a:gd name="T2" fmla="*/ 10323 w 10323"/>
                <a:gd name="T3" fmla="*/ 2004 h 2010"/>
                <a:gd name="T4" fmla="*/ 10323 w 10323"/>
                <a:gd name="T5" fmla="*/ 2010 h 2010"/>
                <a:gd name="T6" fmla="*/ 0 w 10323"/>
                <a:gd name="T7" fmla="*/ 2010 h 2010"/>
                <a:gd name="T8" fmla="*/ 0 w 10323"/>
                <a:gd name="T9" fmla="*/ 2004 h 2010"/>
                <a:gd name="T10" fmla="*/ 0 w 10323"/>
                <a:gd name="T11" fmla="*/ 1604 h 2010"/>
                <a:gd name="T12" fmla="*/ 10323 w 10323"/>
                <a:gd name="T13" fmla="*/ 1604 h 2010"/>
                <a:gd name="T14" fmla="*/ 10323 w 10323"/>
                <a:gd name="T15" fmla="*/ 1610 h 2010"/>
                <a:gd name="T16" fmla="*/ 0 w 10323"/>
                <a:gd name="T17" fmla="*/ 1610 h 2010"/>
                <a:gd name="T18" fmla="*/ 0 w 10323"/>
                <a:gd name="T19" fmla="*/ 1604 h 2010"/>
                <a:gd name="T20" fmla="*/ 0 w 10323"/>
                <a:gd name="T21" fmla="*/ 1202 h 2010"/>
                <a:gd name="T22" fmla="*/ 10323 w 10323"/>
                <a:gd name="T23" fmla="*/ 1202 h 2010"/>
                <a:gd name="T24" fmla="*/ 10323 w 10323"/>
                <a:gd name="T25" fmla="*/ 1208 h 2010"/>
                <a:gd name="T26" fmla="*/ 0 w 10323"/>
                <a:gd name="T27" fmla="*/ 1208 h 2010"/>
                <a:gd name="T28" fmla="*/ 0 w 10323"/>
                <a:gd name="T29" fmla="*/ 1202 h 2010"/>
                <a:gd name="T30" fmla="*/ 0 w 10323"/>
                <a:gd name="T31" fmla="*/ 801 h 2010"/>
                <a:gd name="T32" fmla="*/ 10323 w 10323"/>
                <a:gd name="T33" fmla="*/ 801 h 2010"/>
                <a:gd name="T34" fmla="*/ 10323 w 10323"/>
                <a:gd name="T35" fmla="*/ 807 h 2010"/>
                <a:gd name="T36" fmla="*/ 0 w 10323"/>
                <a:gd name="T37" fmla="*/ 807 h 2010"/>
                <a:gd name="T38" fmla="*/ 0 w 10323"/>
                <a:gd name="T39" fmla="*/ 801 h 2010"/>
                <a:gd name="T40" fmla="*/ 0 w 10323"/>
                <a:gd name="T41" fmla="*/ 401 h 2010"/>
                <a:gd name="T42" fmla="*/ 10323 w 10323"/>
                <a:gd name="T43" fmla="*/ 401 h 2010"/>
                <a:gd name="T44" fmla="*/ 10323 w 10323"/>
                <a:gd name="T45" fmla="*/ 407 h 2010"/>
                <a:gd name="T46" fmla="*/ 0 w 10323"/>
                <a:gd name="T47" fmla="*/ 407 h 2010"/>
                <a:gd name="T48" fmla="*/ 0 w 10323"/>
                <a:gd name="T49" fmla="*/ 401 h 2010"/>
                <a:gd name="T50" fmla="*/ 0 w 10323"/>
                <a:gd name="T51" fmla="*/ 0 h 2010"/>
                <a:gd name="T52" fmla="*/ 10323 w 10323"/>
                <a:gd name="T53" fmla="*/ 0 h 2010"/>
                <a:gd name="T54" fmla="*/ 10323 w 10323"/>
                <a:gd name="T55" fmla="*/ 5 h 2010"/>
                <a:gd name="T56" fmla="*/ 0 w 10323"/>
                <a:gd name="T57" fmla="*/ 5 h 2010"/>
                <a:gd name="T58" fmla="*/ 0 w 10323"/>
                <a:gd name="T59" fmla="*/ 0 h 20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10323" h="2010">
                  <a:moveTo>
                    <a:pt x="0" y="2004"/>
                  </a:moveTo>
                  <a:lnTo>
                    <a:pt x="10323" y="2004"/>
                  </a:lnTo>
                  <a:lnTo>
                    <a:pt x="10323" y="2010"/>
                  </a:lnTo>
                  <a:lnTo>
                    <a:pt x="0" y="2010"/>
                  </a:lnTo>
                  <a:lnTo>
                    <a:pt x="0" y="2004"/>
                  </a:lnTo>
                  <a:close/>
                  <a:moveTo>
                    <a:pt x="0" y="1604"/>
                  </a:moveTo>
                  <a:lnTo>
                    <a:pt x="10323" y="1604"/>
                  </a:lnTo>
                  <a:lnTo>
                    <a:pt x="10323" y="1610"/>
                  </a:lnTo>
                  <a:lnTo>
                    <a:pt x="0" y="1610"/>
                  </a:lnTo>
                  <a:lnTo>
                    <a:pt x="0" y="1604"/>
                  </a:lnTo>
                  <a:close/>
                  <a:moveTo>
                    <a:pt x="0" y="1202"/>
                  </a:moveTo>
                  <a:lnTo>
                    <a:pt x="10323" y="1202"/>
                  </a:lnTo>
                  <a:lnTo>
                    <a:pt x="10323" y="1208"/>
                  </a:lnTo>
                  <a:lnTo>
                    <a:pt x="0" y="1208"/>
                  </a:lnTo>
                  <a:lnTo>
                    <a:pt x="0" y="1202"/>
                  </a:lnTo>
                  <a:close/>
                  <a:moveTo>
                    <a:pt x="0" y="801"/>
                  </a:moveTo>
                  <a:lnTo>
                    <a:pt x="10323" y="801"/>
                  </a:lnTo>
                  <a:lnTo>
                    <a:pt x="10323" y="807"/>
                  </a:lnTo>
                  <a:lnTo>
                    <a:pt x="0" y="807"/>
                  </a:lnTo>
                  <a:lnTo>
                    <a:pt x="0" y="801"/>
                  </a:lnTo>
                  <a:close/>
                  <a:moveTo>
                    <a:pt x="0" y="401"/>
                  </a:moveTo>
                  <a:lnTo>
                    <a:pt x="10323" y="401"/>
                  </a:lnTo>
                  <a:lnTo>
                    <a:pt x="10323" y="407"/>
                  </a:lnTo>
                  <a:lnTo>
                    <a:pt x="0" y="407"/>
                  </a:lnTo>
                  <a:lnTo>
                    <a:pt x="0" y="401"/>
                  </a:lnTo>
                  <a:close/>
                  <a:moveTo>
                    <a:pt x="0" y="0"/>
                  </a:moveTo>
                  <a:lnTo>
                    <a:pt x="10323" y="0"/>
                  </a:lnTo>
                  <a:lnTo>
                    <a:pt x="10323" y="5"/>
                  </a:lnTo>
                  <a:lnTo>
                    <a:pt x="0" y="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" name="Freeform 9"/>
            <p:cNvSpPr>
              <a:spLocks noEditPoints="1"/>
            </p:cNvSpPr>
            <p:nvPr/>
          </p:nvSpPr>
          <p:spPr bwMode="auto">
            <a:xfrm>
              <a:off x="1323443" y="771824"/>
              <a:ext cx="7208615" cy="1672805"/>
            </a:xfrm>
            <a:custGeom>
              <a:avLst/>
              <a:gdLst>
                <a:gd name="T0" fmla="*/ 142 w 10110"/>
                <a:gd name="T1" fmla="*/ 2168 h 2182"/>
                <a:gd name="T2" fmla="*/ 356 w 10110"/>
                <a:gd name="T3" fmla="*/ 2168 h 2182"/>
                <a:gd name="T4" fmla="*/ 356 w 10110"/>
                <a:gd name="T5" fmla="*/ 2170 h 2182"/>
                <a:gd name="T6" fmla="*/ 854 w 10110"/>
                <a:gd name="T7" fmla="*/ 2154 h 2182"/>
                <a:gd name="T8" fmla="*/ 712 w 10110"/>
                <a:gd name="T9" fmla="*/ 2154 h 2182"/>
                <a:gd name="T10" fmla="*/ 1210 w 10110"/>
                <a:gd name="T11" fmla="*/ 2168 h 2182"/>
                <a:gd name="T12" fmla="*/ 1424 w 10110"/>
                <a:gd name="T13" fmla="*/ 108 h 2182"/>
                <a:gd name="T14" fmla="*/ 1424 w 10110"/>
                <a:gd name="T15" fmla="*/ 2168 h 2182"/>
                <a:gd name="T16" fmla="*/ 1922 w 10110"/>
                <a:gd name="T17" fmla="*/ 2166 h 2182"/>
                <a:gd name="T18" fmla="*/ 1780 w 10110"/>
                <a:gd name="T19" fmla="*/ 2166 h 2182"/>
                <a:gd name="T20" fmla="*/ 2278 w 10110"/>
                <a:gd name="T21" fmla="*/ 2178 h 2182"/>
                <a:gd name="T22" fmla="*/ 2492 w 10110"/>
                <a:gd name="T23" fmla="*/ 2155 h 2182"/>
                <a:gd name="T24" fmla="*/ 2492 w 10110"/>
                <a:gd name="T25" fmla="*/ 2168 h 2182"/>
                <a:gd name="T26" fmla="*/ 2990 w 10110"/>
                <a:gd name="T27" fmla="*/ 651 h 2182"/>
                <a:gd name="T28" fmla="*/ 2847 w 10110"/>
                <a:gd name="T29" fmla="*/ 651 h 2182"/>
                <a:gd name="T30" fmla="*/ 3346 w 10110"/>
                <a:gd name="T31" fmla="*/ 2168 h 2182"/>
                <a:gd name="T32" fmla="*/ 3560 w 10110"/>
                <a:gd name="T33" fmla="*/ 2168 h 2182"/>
                <a:gd name="T34" fmla="*/ 3560 w 10110"/>
                <a:gd name="T35" fmla="*/ 2173 h 2182"/>
                <a:gd name="T36" fmla="*/ 4058 w 10110"/>
                <a:gd name="T37" fmla="*/ 2158 h 2182"/>
                <a:gd name="T38" fmla="*/ 3916 w 10110"/>
                <a:gd name="T39" fmla="*/ 2158 h 2182"/>
                <a:gd name="T40" fmla="*/ 4414 w 10110"/>
                <a:gd name="T41" fmla="*/ 2168 h 2182"/>
                <a:gd name="T42" fmla="*/ 4627 w 10110"/>
                <a:gd name="T43" fmla="*/ 2159 h 2182"/>
                <a:gd name="T44" fmla="*/ 4627 w 10110"/>
                <a:gd name="T45" fmla="*/ 2168 h 2182"/>
                <a:gd name="T46" fmla="*/ 5126 w 10110"/>
                <a:gd name="T47" fmla="*/ 2168 h 2182"/>
                <a:gd name="T48" fmla="*/ 4983 w 10110"/>
                <a:gd name="T49" fmla="*/ 2168 h 2182"/>
                <a:gd name="T50" fmla="*/ 5481 w 10110"/>
                <a:gd name="T51" fmla="*/ 2168 h 2182"/>
                <a:gd name="T52" fmla="*/ 5696 w 10110"/>
                <a:gd name="T53" fmla="*/ 2168 h 2182"/>
                <a:gd name="T54" fmla="*/ 5696 w 10110"/>
                <a:gd name="T55" fmla="*/ 2177 h 2182"/>
                <a:gd name="T56" fmla="*/ 6194 w 10110"/>
                <a:gd name="T57" fmla="*/ 2158 h 2182"/>
                <a:gd name="T58" fmla="*/ 6052 w 10110"/>
                <a:gd name="T59" fmla="*/ 2158 h 2182"/>
                <a:gd name="T60" fmla="*/ 6550 w 10110"/>
                <a:gd name="T61" fmla="*/ 2168 h 2182"/>
                <a:gd name="T62" fmla="*/ 6763 w 10110"/>
                <a:gd name="T63" fmla="*/ 0 h 2182"/>
                <a:gd name="T64" fmla="*/ 6763 w 10110"/>
                <a:gd name="T65" fmla="*/ 2168 h 2182"/>
                <a:gd name="T66" fmla="*/ 7261 w 10110"/>
                <a:gd name="T67" fmla="*/ 128 h 2182"/>
                <a:gd name="T68" fmla="*/ 7119 w 10110"/>
                <a:gd name="T69" fmla="*/ 128 h 2182"/>
                <a:gd name="T70" fmla="*/ 7617 w 10110"/>
                <a:gd name="T71" fmla="*/ 2168 h 2182"/>
                <a:gd name="T72" fmla="*/ 7832 w 10110"/>
                <a:gd name="T73" fmla="*/ 2156 h 2182"/>
                <a:gd name="T74" fmla="*/ 7832 w 10110"/>
                <a:gd name="T75" fmla="*/ 2168 h 2182"/>
                <a:gd name="T76" fmla="*/ 8330 w 10110"/>
                <a:gd name="T77" fmla="*/ 2168 h 2182"/>
                <a:gd name="T78" fmla="*/ 8188 w 10110"/>
                <a:gd name="T79" fmla="*/ 2168 h 2182"/>
                <a:gd name="T80" fmla="*/ 8686 w 10110"/>
                <a:gd name="T81" fmla="*/ 2168 h 2182"/>
                <a:gd name="T82" fmla="*/ 8899 w 10110"/>
                <a:gd name="T83" fmla="*/ 2099 h 2182"/>
                <a:gd name="T84" fmla="*/ 8899 w 10110"/>
                <a:gd name="T85" fmla="*/ 2168 h 2182"/>
                <a:gd name="T86" fmla="*/ 9397 w 10110"/>
                <a:gd name="T87" fmla="*/ 2168 h 2182"/>
                <a:gd name="T88" fmla="*/ 9255 w 10110"/>
                <a:gd name="T89" fmla="*/ 2168 h 2182"/>
                <a:gd name="T90" fmla="*/ 9753 w 10110"/>
                <a:gd name="T91" fmla="*/ 2168 h 2182"/>
                <a:gd name="T92" fmla="*/ 9968 w 10110"/>
                <a:gd name="T93" fmla="*/ 2124 h 2182"/>
                <a:gd name="T94" fmla="*/ 9968 w 10110"/>
                <a:gd name="T95" fmla="*/ 2168 h 21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</a:cxnLst>
              <a:rect l="0" t="0" r="r" b="b"/>
              <a:pathLst>
                <a:path w="10110" h="2182">
                  <a:moveTo>
                    <a:pt x="0" y="2167"/>
                  </a:moveTo>
                  <a:lnTo>
                    <a:pt x="142" y="2167"/>
                  </a:lnTo>
                  <a:lnTo>
                    <a:pt x="142" y="2168"/>
                  </a:lnTo>
                  <a:lnTo>
                    <a:pt x="0" y="2168"/>
                  </a:lnTo>
                  <a:lnTo>
                    <a:pt x="0" y="2167"/>
                  </a:lnTo>
                  <a:close/>
                  <a:moveTo>
                    <a:pt x="356" y="2168"/>
                  </a:moveTo>
                  <a:lnTo>
                    <a:pt x="498" y="2168"/>
                  </a:lnTo>
                  <a:lnTo>
                    <a:pt x="498" y="2170"/>
                  </a:lnTo>
                  <a:lnTo>
                    <a:pt x="356" y="2170"/>
                  </a:lnTo>
                  <a:lnTo>
                    <a:pt x="356" y="2168"/>
                  </a:lnTo>
                  <a:close/>
                  <a:moveTo>
                    <a:pt x="712" y="2154"/>
                  </a:moveTo>
                  <a:lnTo>
                    <a:pt x="854" y="2154"/>
                  </a:lnTo>
                  <a:lnTo>
                    <a:pt x="854" y="2168"/>
                  </a:lnTo>
                  <a:lnTo>
                    <a:pt x="712" y="2168"/>
                  </a:lnTo>
                  <a:lnTo>
                    <a:pt x="712" y="2154"/>
                  </a:lnTo>
                  <a:close/>
                  <a:moveTo>
                    <a:pt x="1067" y="784"/>
                  </a:moveTo>
                  <a:lnTo>
                    <a:pt x="1210" y="784"/>
                  </a:lnTo>
                  <a:lnTo>
                    <a:pt x="1210" y="2168"/>
                  </a:lnTo>
                  <a:lnTo>
                    <a:pt x="1067" y="2168"/>
                  </a:lnTo>
                  <a:lnTo>
                    <a:pt x="1067" y="784"/>
                  </a:lnTo>
                  <a:close/>
                  <a:moveTo>
                    <a:pt x="1424" y="108"/>
                  </a:moveTo>
                  <a:lnTo>
                    <a:pt x="1566" y="108"/>
                  </a:lnTo>
                  <a:lnTo>
                    <a:pt x="1566" y="2168"/>
                  </a:lnTo>
                  <a:lnTo>
                    <a:pt x="1424" y="2168"/>
                  </a:lnTo>
                  <a:lnTo>
                    <a:pt x="1424" y="108"/>
                  </a:lnTo>
                  <a:close/>
                  <a:moveTo>
                    <a:pt x="1780" y="2166"/>
                  </a:moveTo>
                  <a:lnTo>
                    <a:pt x="1922" y="2166"/>
                  </a:lnTo>
                  <a:lnTo>
                    <a:pt x="1922" y="2168"/>
                  </a:lnTo>
                  <a:lnTo>
                    <a:pt x="1780" y="2168"/>
                  </a:lnTo>
                  <a:lnTo>
                    <a:pt x="1780" y="2166"/>
                  </a:lnTo>
                  <a:close/>
                  <a:moveTo>
                    <a:pt x="2136" y="2168"/>
                  </a:moveTo>
                  <a:lnTo>
                    <a:pt x="2278" y="2168"/>
                  </a:lnTo>
                  <a:lnTo>
                    <a:pt x="2278" y="2178"/>
                  </a:lnTo>
                  <a:lnTo>
                    <a:pt x="2136" y="2178"/>
                  </a:lnTo>
                  <a:lnTo>
                    <a:pt x="2136" y="2168"/>
                  </a:lnTo>
                  <a:close/>
                  <a:moveTo>
                    <a:pt x="2492" y="2155"/>
                  </a:moveTo>
                  <a:lnTo>
                    <a:pt x="2634" y="2155"/>
                  </a:lnTo>
                  <a:lnTo>
                    <a:pt x="2634" y="2168"/>
                  </a:lnTo>
                  <a:lnTo>
                    <a:pt x="2492" y="2168"/>
                  </a:lnTo>
                  <a:lnTo>
                    <a:pt x="2492" y="2155"/>
                  </a:lnTo>
                  <a:close/>
                  <a:moveTo>
                    <a:pt x="2847" y="651"/>
                  </a:moveTo>
                  <a:lnTo>
                    <a:pt x="2990" y="651"/>
                  </a:lnTo>
                  <a:lnTo>
                    <a:pt x="2990" y="2168"/>
                  </a:lnTo>
                  <a:lnTo>
                    <a:pt x="2847" y="2168"/>
                  </a:lnTo>
                  <a:lnTo>
                    <a:pt x="2847" y="651"/>
                  </a:lnTo>
                  <a:close/>
                  <a:moveTo>
                    <a:pt x="3203" y="2165"/>
                  </a:moveTo>
                  <a:lnTo>
                    <a:pt x="3346" y="2165"/>
                  </a:lnTo>
                  <a:lnTo>
                    <a:pt x="3346" y="2168"/>
                  </a:lnTo>
                  <a:lnTo>
                    <a:pt x="3203" y="2168"/>
                  </a:lnTo>
                  <a:lnTo>
                    <a:pt x="3203" y="2165"/>
                  </a:lnTo>
                  <a:close/>
                  <a:moveTo>
                    <a:pt x="3560" y="2168"/>
                  </a:moveTo>
                  <a:lnTo>
                    <a:pt x="3702" y="2168"/>
                  </a:lnTo>
                  <a:lnTo>
                    <a:pt x="3702" y="2173"/>
                  </a:lnTo>
                  <a:lnTo>
                    <a:pt x="3560" y="2173"/>
                  </a:lnTo>
                  <a:lnTo>
                    <a:pt x="3560" y="2168"/>
                  </a:lnTo>
                  <a:close/>
                  <a:moveTo>
                    <a:pt x="3916" y="2158"/>
                  </a:moveTo>
                  <a:lnTo>
                    <a:pt x="4058" y="2158"/>
                  </a:lnTo>
                  <a:lnTo>
                    <a:pt x="4058" y="2168"/>
                  </a:lnTo>
                  <a:lnTo>
                    <a:pt x="3916" y="2168"/>
                  </a:lnTo>
                  <a:lnTo>
                    <a:pt x="3916" y="2158"/>
                  </a:lnTo>
                  <a:close/>
                  <a:moveTo>
                    <a:pt x="4272" y="2164"/>
                  </a:moveTo>
                  <a:lnTo>
                    <a:pt x="4414" y="2164"/>
                  </a:lnTo>
                  <a:lnTo>
                    <a:pt x="4414" y="2168"/>
                  </a:lnTo>
                  <a:lnTo>
                    <a:pt x="4272" y="2168"/>
                  </a:lnTo>
                  <a:lnTo>
                    <a:pt x="4272" y="2164"/>
                  </a:lnTo>
                  <a:close/>
                  <a:moveTo>
                    <a:pt x="4627" y="2159"/>
                  </a:moveTo>
                  <a:lnTo>
                    <a:pt x="4770" y="2159"/>
                  </a:lnTo>
                  <a:lnTo>
                    <a:pt x="4770" y="2168"/>
                  </a:lnTo>
                  <a:lnTo>
                    <a:pt x="4627" y="2168"/>
                  </a:lnTo>
                  <a:lnTo>
                    <a:pt x="4627" y="2159"/>
                  </a:lnTo>
                  <a:close/>
                  <a:moveTo>
                    <a:pt x="4983" y="2168"/>
                  </a:moveTo>
                  <a:lnTo>
                    <a:pt x="5126" y="2168"/>
                  </a:lnTo>
                  <a:lnTo>
                    <a:pt x="5126" y="2173"/>
                  </a:lnTo>
                  <a:lnTo>
                    <a:pt x="4983" y="2173"/>
                  </a:lnTo>
                  <a:lnTo>
                    <a:pt x="4983" y="2168"/>
                  </a:lnTo>
                  <a:close/>
                  <a:moveTo>
                    <a:pt x="5339" y="2166"/>
                  </a:moveTo>
                  <a:lnTo>
                    <a:pt x="5481" y="2166"/>
                  </a:lnTo>
                  <a:lnTo>
                    <a:pt x="5481" y="2168"/>
                  </a:lnTo>
                  <a:lnTo>
                    <a:pt x="5339" y="2168"/>
                  </a:lnTo>
                  <a:lnTo>
                    <a:pt x="5339" y="2166"/>
                  </a:lnTo>
                  <a:close/>
                  <a:moveTo>
                    <a:pt x="5696" y="2168"/>
                  </a:moveTo>
                  <a:lnTo>
                    <a:pt x="5838" y="2168"/>
                  </a:lnTo>
                  <a:lnTo>
                    <a:pt x="5838" y="2177"/>
                  </a:lnTo>
                  <a:lnTo>
                    <a:pt x="5696" y="2177"/>
                  </a:lnTo>
                  <a:lnTo>
                    <a:pt x="5696" y="2168"/>
                  </a:lnTo>
                  <a:close/>
                  <a:moveTo>
                    <a:pt x="6052" y="2158"/>
                  </a:moveTo>
                  <a:lnTo>
                    <a:pt x="6194" y="2158"/>
                  </a:lnTo>
                  <a:lnTo>
                    <a:pt x="6194" y="2168"/>
                  </a:lnTo>
                  <a:lnTo>
                    <a:pt x="6052" y="2168"/>
                  </a:lnTo>
                  <a:lnTo>
                    <a:pt x="6052" y="2158"/>
                  </a:lnTo>
                  <a:close/>
                  <a:moveTo>
                    <a:pt x="6408" y="2139"/>
                  </a:moveTo>
                  <a:lnTo>
                    <a:pt x="6550" y="2139"/>
                  </a:lnTo>
                  <a:lnTo>
                    <a:pt x="6550" y="2168"/>
                  </a:lnTo>
                  <a:lnTo>
                    <a:pt x="6408" y="2168"/>
                  </a:lnTo>
                  <a:lnTo>
                    <a:pt x="6408" y="2139"/>
                  </a:lnTo>
                  <a:close/>
                  <a:moveTo>
                    <a:pt x="6763" y="0"/>
                  </a:moveTo>
                  <a:lnTo>
                    <a:pt x="6906" y="0"/>
                  </a:lnTo>
                  <a:lnTo>
                    <a:pt x="6906" y="2168"/>
                  </a:lnTo>
                  <a:lnTo>
                    <a:pt x="6763" y="2168"/>
                  </a:lnTo>
                  <a:lnTo>
                    <a:pt x="6763" y="0"/>
                  </a:lnTo>
                  <a:close/>
                  <a:moveTo>
                    <a:pt x="7119" y="128"/>
                  </a:moveTo>
                  <a:lnTo>
                    <a:pt x="7261" y="128"/>
                  </a:lnTo>
                  <a:lnTo>
                    <a:pt x="7261" y="2168"/>
                  </a:lnTo>
                  <a:lnTo>
                    <a:pt x="7119" y="2168"/>
                  </a:lnTo>
                  <a:lnTo>
                    <a:pt x="7119" y="128"/>
                  </a:lnTo>
                  <a:close/>
                  <a:moveTo>
                    <a:pt x="7475" y="415"/>
                  </a:moveTo>
                  <a:lnTo>
                    <a:pt x="7617" y="415"/>
                  </a:lnTo>
                  <a:lnTo>
                    <a:pt x="7617" y="2168"/>
                  </a:lnTo>
                  <a:lnTo>
                    <a:pt x="7475" y="2168"/>
                  </a:lnTo>
                  <a:lnTo>
                    <a:pt x="7475" y="415"/>
                  </a:lnTo>
                  <a:close/>
                  <a:moveTo>
                    <a:pt x="7832" y="2156"/>
                  </a:moveTo>
                  <a:lnTo>
                    <a:pt x="7974" y="2156"/>
                  </a:lnTo>
                  <a:lnTo>
                    <a:pt x="7974" y="2168"/>
                  </a:lnTo>
                  <a:lnTo>
                    <a:pt x="7832" y="2168"/>
                  </a:lnTo>
                  <a:lnTo>
                    <a:pt x="7832" y="2156"/>
                  </a:lnTo>
                  <a:close/>
                  <a:moveTo>
                    <a:pt x="8188" y="2168"/>
                  </a:moveTo>
                  <a:lnTo>
                    <a:pt x="8330" y="2168"/>
                  </a:lnTo>
                  <a:lnTo>
                    <a:pt x="8330" y="2182"/>
                  </a:lnTo>
                  <a:lnTo>
                    <a:pt x="8188" y="2182"/>
                  </a:lnTo>
                  <a:lnTo>
                    <a:pt x="8188" y="2168"/>
                  </a:lnTo>
                  <a:close/>
                  <a:moveTo>
                    <a:pt x="8543" y="2156"/>
                  </a:moveTo>
                  <a:lnTo>
                    <a:pt x="8686" y="2156"/>
                  </a:lnTo>
                  <a:lnTo>
                    <a:pt x="8686" y="2168"/>
                  </a:lnTo>
                  <a:lnTo>
                    <a:pt x="8543" y="2168"/>
                  </a:lnTo>
                  <a:lnTo>
                    <a:pt x="8543" y="2156"/>
                  </a:lnTo>
                  <a:close/>
                  <a:moveTo>
                    <a:pt x="8899" y="2099"/>
                  </a:moveTo>
                  <a:lnTo>
                    <a:pt x="9042" y="2099"/>
                  </a:lnTo>
                  <a:lnTo>
                    <a:pt x="9042" y="2168"/>
                  </a:lnTo>
                  <a:lnTo>
                    <a:pt x="8899" y="2168"/>
                  </a:lnTo>
                  <a:lnTo>
                    <a:pt x="8899" y="2099"/>
                  </a:lnTo>
                  <a:close/>
                  <a:moveTo>
                    <a:pt x="9255" y="2168"/>
                  </a:moveTo>
                  <a:lnTo>
                    <a:pt x="9397" y="2168"/>
                  </a:lnTo>
                  <a:lnTo>
                    <a:pt x="9397" y="2175"/>
                  </a:lnTo>
                  <a:lnTo>
                    <a:pt x="9255" y="2175"/>
                  </a:lnTo>
                  <a:lnTo>
                    <a:pt x="9255" y="2168"/>
                  </a:lnTo>
                  <a:close/>
                  <a:moveTo>
                    <a:pt x="9611" y="2159"/>
                  </a:moveTo>
                  <a:lnTo>
                    <a:pt x="9753" y="2159"/>
                  </a:lnTo>
                  <a:lnTo>
                    <a:pt x="9753" y="2168"/>
                  </a:lnTo>
                  <a:lnTo>
                    <a:pt x="9611" y="2168"/>
                  </a:lnTo>
                  <a:lnTo>
                    <a:pt x="9611" y="2159"/>
                  </a:lnTo>
                  <a:close/>
                  <a:moveTo>
                    <a:pt x="9968" y="2124"/>
                  </a:moveTo>
                  <a:lnTo>
                    <a:pt x="10110" y="2124"/>
                  </a:lnTo>
                  <a:lnTo>
                    <a:pt x="10110" y="2168"/>
                  </a:lnTo>
                  <a:lnTo>
                    <a:pt x="9968" y="2168"/>
                  </a:lnTo>
                  <a:lnTo>
                    <a:pt x="9968" y="2124"/>
                  </a:lnTo>
                  <a:close/>
                </a:path>
              </a:pathLst>
            </a:custGeom>
            <a:solidFill>
              <a:srgbClr val="C00000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Rectangle 10"/>
            <p:cNvSpPr>
              <a:spLocks noChangeArrowheads="1"/>
            </p:cNvSpPr>
            <p:nvPr/>
          </p:nvSpPr>
          <p:spPr bwMode="auto">
            <a:xfrm>
              <a:off x="1245011" y="589364"/>
              <a:ext cx="4278" cy="1844532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" name="Freeform 11"/>
            <p:cNvSpPr>
              <a:spLocks noEditPoints="1"/>
            </p:cNvSpPr>
            <p:nvPr/>
          </p:nvSpPr>
          <p:spPr bwMode="auto">
            <a:xfrm>
              <a:off x="1219342" y="587831"/>
              <a:ext cx="27808" cy="1848365"/>
            </a:xfrm>
            <a:custGeom>
              <a:avLst/>
              <a:gdLst>
                <a:gd name="T0" fmla="*/ 0 w 39"/>
                <a:gd name="T1" fmla="*/ 2405 h 2411"/>
                <a:gd name="T2" fmla="*/ 39 w 39"/>
                <a:gd name="T3" fmla="*/ 2405 h 2411"/>
                <a:gd name="T4" fmla="*/ 39 w 39"/>
                <a:gd name="T5" fmla="*/ 2411 h 2411"/>
                <a:gd name="T6" fmla="*/ 0 w 39"/>
                <a:gd name="T7" fmla="*/ 2411 h 2411"/>
                <a:gd name="T8" fmla="*/ 0 w 39"/>
                <a:gd name="T9" fmla="*/ 2405 h 2411"/>
                <a:gd name="T10" fmla="*/ 0 w 39"/>
                <a:gd name="T11" fmla="*/ 2004 h 2411"/>
                <a:gd name="T12" fmla="*/ 39 w 39"/>
                <a:gd name="T13" fmla="*/ 2004 h 2411"/>
                <a:gd name="T14" fmla="*/ 39 w 39"/>
                <a:gd name="T15" fmla="*/ 2010 h 2411"/>
                <a:gd name="T16" fmla="*/ 0 w 39"/>
                <a:gd name="T17" fmla="*/ 2010 h 2411"/>
                <a:gd name="T18" fmla="*/ 0 w 39"/>
                <a:gd name="T19" fmla="*/ 2004 h 2411"/>
                <a:gd name="T20" fmla="*/ 0 w 39"/>
                <a:gd name="T21" fmla="*/ 1604 h 2411"/>
                <a:gd name="T22" fmla="*/ 39 w 39"/>
                <a:gd name="T23" fmla="*/ 1604 h 2411"/>
                <a:gd name="T24" fmla="*/ 39 w 39"/>
                <a:gd name="T25" fmla="*/ 1610 h 2411"/>
                <a:gd name="T26" fmla="*/ 0 w 39"/>
                <a:gd name="T27" fmla="*/ 1610 h 2411"/>
                <a:gd name="T28" fmla="*/ 0 w 39"/>
                <a:gd name="T29" fmla="*/ 1604 h 2411"/>
                <a:gd name="T30" fmla="*/ 0 w 39"/>
                <a:gd name="T31" fmla="*/ 1202 h 2411"/>
                <a:gd name="T32" fmla="*/ 39 w 39"/>
                <a:gd name="T33" fmla="*/ 1202 h 2411"/>
                <a:gd name="T34" fmla="*/ 39 w 39"/>
                <a:gd name="T35" fmla="*/ 1208 h 2411"/>
                <a:gd name="T36" fmla="*/ 0 w 39"/>
                <a:gd name="T37" fmla="*/ 1208 h 2411"/>
                <a:gd name="T38" fmla="*/ 0 w 39"/>
                <a:gd name="T39" fmla="*/ 1202 h 2411"/>
                <a:gd name="T40" fmla="*/ 0 w 39"/>
                <a:gd name="T41" fmla="*/ 801 h 2411"/>
                <a:gd name="T42" fmla="*/ 39 w 39"/>
                <a:gd name="T43" fmla="*/ 801 h 2411"/>
                <a:gd name="T44" fmla="*/ 39 w 39"/>
                <a:gd name="T45" fmla="*/ 807 h 2411"/>
                <a:gd name="T46" fmla="*/ 0 w 39"/>
                <a:gd name="T47" fmla="*/ 807 h 2411"/>
                <a:gd name="T48" fmla="*/ 0 w 39"/>
                <a:gd name="T49" fmla="*/ 801 h 2411"/>
                <a:gd name="T50" fmla="*/ 0 w 39"/>
                <a:gd name="T51" fmla="*/ 401 h 2411"/>
                <a:gd name="T52" fmla="*/ 39 w 39"/>
                <a:gd name="T53" fmla="*/ 401 h 2411"/>
                <a:gd name="T54" fmla="*/ 39 w 39"/>
                <a:gd name="T55" fmla="*/ 407 h 2411"/>
                <a:gd name="T56" fmla="*/ 0 w 39"/>
                <a:gd name="T57" fmla="*/ 407 h 2411"/>
                <a:gd name="T58" fmla="*/ 0 w 39"/>
                <a:gd name="T59" fmla="*/ 401 h 2411"/>
                <a:gd name="T60" fmla="*/ 0 w 39"/>
                <a:gd name="T61" fmla="*/ 0 h 2411"/>
                <a:gd name="T62" fmla="*/ 39 w 39"/>
                <a:gd name="T63" fmla="*/ 0 h 2411"/>
                <a:gd name="T64" fmla="*/ 39 w 39"/>
                <a:gd name="T65" fmla="*/ 5 h 2411"/>
                <a:gd name="T66" fmla="*/ 0 w 39"/>
                <a:gd name="T67" fmla="*/ 5 h 2411"/>
                <a:gd name="T68" fmla="*/ 0 w 39"/>
                <a:gd name="T69" fmla="*/ 0 h 24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</a:cxnLst>
              <a:rect l="0" t="0" r="r" b="b"/>
              <a:pathLst>
                <a:path w="39" h="2411">
                  <a:moveTo>
                    <a:pt x="0" y="2405"/>
                  </a:moveTo>
                  <a:lnTo>
                    <a:pt x="39" y="2405"/>
                  </a:lnTo>
                  <a:lnTo>
                    <a:pt x="39" y="2411"/>
                  </a:lnTo>
                  <a:lnTo>
                    <a:pt x="0" y="2411"/>
                  </a:lnTo>
                  <a:lnTo>
                    <a:pt x="0" y="2405"/>
                  </a:lnTo>
                  <a:close/>
                  <a:moveTo>
                    <a:pt x="0" y="2004"/>
                  </a:moveTo>
                  <a:lnTo>
                    <a:pt x="39" y="2004"/>
                  </a:lnTo>
                  <a:lnTo>
                    <a:pt x="39" y="2010"/>
                  </a:lnTo>
                  <a:lnTo>
                    <a:pt x="0" y="2010"/>
                  </a:lnTo>
                  <a:lnTo>
                    <a:pt x="0" y="2004"/>
                  </a:lnTo>
                  <a:close/>
                  <a:moveTo>
                    <a:pt x="0" y="1604"/>
                  </a:moveTo>
                  <a:lnTo>
                    <a:pt x="39" y="1604"/>
                  </a:lnTo>
                  <a:lnTo>
                    <a:pt x="39" y="1610"/>
                  </a:lnTo>
                  <a:lnTo>
                    <a:pt x="0" y="1610"/>
                  </a:lnTo>
                  <a:lnTo>
                    <a:pt x="0" y="1604"/>
                  </a:lnTo>
                  <a:close/>
                  <a:moveTo>
                    <a:pt x="0" y="1202"/>
                  </a:moveTo>
                  <a:lnTo>
                    <a:pt x="39" y="1202"/>
                  </a:lnTo>
                  <a:lnTo>
                    <a:pt x="39" y="1208"/>
                  </a:lnTo>
                  <a:lnTo>
                    <a:pt x="0" y="1208"/>
                  </a:lnTo>
                  <a:lnTo>
                    <a:pt x="0" y="1202"/>
                  </a:lnTo>
                  <a:close/>
                  <a:moveTo>
                    <a:pt x="0" y="801"/>
                  </a:moveTo>
                  <a:lnTo>
                    <a:pt x="39" y="801"/>
                  </a:lnTo>
                  <a:lnTo>
                    <a:pt x="39" y="807"/>
                  </a:lnTo>
                  <a:lnTo>
                    <a:pt x="0" y="807"/>
                  </a:lnTo>
                  <a:lnTo>
                    <a:pt x="0" y="801"/>
                  </a:lnTo>
                  <a:close/>
                  <a:moveTo>
                    <a:pt x="0" y="401"/>
                  </a:moveTo>
                  <a:lnTo>
                    <a:pt x="39" y="401"/>
                  </a:lnTo>
                  <a:lnTo>
                    <a:pt x="39" y="407"/>
                  </a:lnTo>
                  <a:lnTo>
                    <a:pt x="0" y="407"/>
                  </a:lnTo>
                  <a:lnTo>
                    <a:pt x="0" y="401"/>
                  </a:lnTo>
                  <a:close/>
                  <a:moveTo>
                    <a:pt x="0" y="0"/>
                  </a:moveTo>
                  <a:lnTo>
                    <a:pt x="39" y="0"/>
                  </a:lnTo>
                  <a:lnTo>
                    <a:pt x="39" y="5"/>
                  </a:lnTo>
                  <a:lnTo>
                    <a:pt x="0" y="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" name="Rectangle 12"/>
            <p:cNvSpPr>
              <a:spLocks noChangeArrowheads="1"/>
            </p:cNvSpPr>
            <p:nvPr/>
          </p:nvSpPr>
          <p:spPr bwMode="auto">
            <a:xfrm>
              <a:off x="1247150" y="2431596"/>
              <a:ext cx="7360488" cy="4600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" name="Freeform 13"/>
            <p:cNvSpPr>
              <a:spLocks noEditPoints="1"/>
            </p:cNvSpPr>
            <p:nvPr/>
          </p:nvSpPr>
          <p:spPr bwMode="auto">
            <a:xfrm>
              <a:off x="1245011" y="2433896"/>
              <a:ext cx="7364766" cy="29899"/>
            </a:xfrm>
            <a:custGeom>
              <a:avLst/>
              <a:gdLst>
                <a:gd name="T0" fmla="*/ 0 w 10329"/>
                <a:gd name="T1" fmla="*/ 39 h 39"/>
                <a:gd name="T2" fmla="*/ 361 w 10329"/>
                <a:gd name="T3" fmla="*/ 0 h 39"/>
                <a:gd name="T4" fmla="*/ 356 w 10329"/>
                <a:gd name="T5" fmla="*/ 0 h 39"/>
                <a:gd name="T6" fmla="*/ 718 w 10329"/>
                <a:gd name="T7" fmla="*/ 39 h 39"/>
                <a:gd name="T8" fmla="*/ 718 w 10329"/>
                <a:gd name="T9" fmla="*/ 0 h 39"/>
                <a:gd name="T10" fmla="*/ 1068 w 10329"/>
                <a:gd name="T11" fmla="*/ 39 h 39"/>
                <a:gd name="T12" fmla="*/ 1430 w 10329"/>
                <a:gd name="T13" fmla="*/ 0 h 39"/>
                <a:gd name="T14" fmla="*/ 1424 w 10329"/>
                <a:gd name="T15" fmla="*/ 0 h 39"/>
                <a:gd name="T16" fmla="*/ 1786 w 10329"/>
                <a:gd name="T17" fmla="*/ 39 h 39"/>
                <a:gd name="T18" fmla="*/ 1786 w 10329"/>
                <a:gd name="T19" fmla="*/ 0 h 39"/>
                <a:gd name="T20" fmla="*/ 2136 w 10329"/>
                <a:gd name="T21" fmla="*/ 39 h 39"/>
                <a:gd name="T22" fmla="*/ 2497 w 10329"/>
                <a:gd name="T23" fmla="*/ 0 h 39"/>
                <a:gd name="T24" fmla="*/ 2492 w 10329"/>
                <a:gd name="T25" fmla="*/ 0 h 39"/>
                <a:gd name="T26" fmla="*/ 2854 w 10329"/>
                <a:gd name="T27" fmla="*/ 39 h 39"/>
                <a:gd name="T28" fmla="*/ 2854 w 10329"/>
                <a:gd name="T29" fmla="*/ 0 h 39"/>
                <a:gd name="T30" fmla="*/ 3204 w 10329"/>
                <a:gd name="T31" fmla="*/ 39 h 39"/>
                <a:gd name="T32" fmla="*/ 3566 w 10329"/>
                <a:gd name="T33" fmla="*/ 0 h 39"/>
                <a:gd name="T34" fmla="*/ 3560 w 10329"/>
                <a:gd name="T35" fmla="*/ 0 h 39"/>
                <a:gd name="T36" fmla="*/ 3922 w 10329"/>
                <a:gd name="T37" fmla="*/ 39 h 39"/>
                <a:gd name="T38" fmla="*/ 3922 w 10329"/>
                <a:gd name="T39" fmla="*/ 0 h 39"/>
                <a:gd name="T40" fmla="*/ 4271 w 10329"/>
                <a:gd name="T41" fmla="*/ 39 h 39"/>
                <a:gd name="T42" fmla="*/ 4633 w 10329"/>
                <a:gd name="T43" fmla="*/ 0 h 39"/>
                <a:gd name="T44" fmla="*/ 4628 w 10329"/>
                <a:gd name="T45" fmla="*/ 0 h 39"/>
                <a:gd name="T46" fmla="*/ 4990 w 10329"/>
                <a:gd name="T47" fmla="*/ 39 h 39"/>
                <a:gd name="T48" fmla="*/ 4990 w 10329"/>
                <a:gd name="T49" fmla="*/ 0 h 39"/>
                <a:gd name="T50" fmla="*/ 5340 w 10329"/>
                <a:gd name="T51" fmla="*/ 39 h 39"/>
                <a:gd name="T52" fmla="*/ 5702 w 10329"/>
                <a:gd name="T53" fmla="*/ 0 h 39"/>
                <a:gd name="T54" fmla="*/ 5696 w 10329"/>
                <a:gd name="T55" fmla="*/ 0 h 39"/>
                <a:gd name="T56" fmla="*/ 6057 w 10329"/>
                <a:gd name="T57" fmla="*/ 39 h 39"/>
                <a:gd name="T58" fmla="*/ 6057 w 10329"/>
                <a:gd name="T59" fmla="*/ 0 h 39"/>
                <a:gd name="T60" fmla="*/ 6407 w 10329"/>
                <a:gd name="T61" fmla="*/ 39 h 39"/>
                <a:gd name="T62" fmla="*/ 6769 w 10329"/>
                <a:gd name="T63" fmla="*/ 0 h 39"/>
                <a:gd name="T64" fmla="*/ 6764 w 10329"/>
                <a:gd name="T65" fmla="*/ 0 h 39"/>
                <a:gd name="T66" fmla="*/ 7126 w 10329"/>
                <a:gd name="T67" fmla="*/ 39 h 39"/>
                <a:gd name="T68" fmla="*/ 7126 w 10329"/>
                <a:gd name="T69" fmla="*/ 0 h 39"/>
                <a:gd name="T70" fmla="*/ 7476 w 10329"/>
                <a:gd name="T71" fmla="*/ 39 h 39"/>
                <a:gd name="T72" fmla="*/ 7838 w 10329"/>
                <a:gd name="T73" fmla="*/ 0 h 39"/>
                <a:gd name="T74" fmla="*/ 7832 w 10329"/>
                <a:gd name="T75" fmla="*/ 0 h 39"/>
                <a:gd name="T76" fmla="*/ 8193 w 10329"/>
                <a:gd name="T77" fmla="*/ 39 h 39"/>
                <a:gd name="T78" fmla="*/ 8193 w 10329"/>
                <a:gd name="T79" fmla="*/ 0 h 39"/>
                <a:gd name="T80" fmla="*/ 8543 w 10329"/>
                <a:gd name="T81" fmla="*/ 39 h 39"/>
                <a:gd name="T82" fmla="*/ 8905 w 10329"/>
                <a:gd name="T83" fmla="*/ 0 h 39"/>
                <a:gd name="T84" fmla="*/ 8900 w 10329"/>
                <a:gd name="T85" fmla="*/ 0 h 39"/>
                <a:gd name="T86" fmla="*/ 9262 w 10329"/>
                <a:gd name="T87" fmla="*/ 39 h 39"/>
                <a:gd name="T88" fmla="*/ 9262 w 10329"/>
                <a:gd name="T89" fmla="*/ 0 h 39"/>
                <a:gd name="T90" fmla="*/ 9612 w 10329"/>
                <a:gd name="T91" fmla="*/ 39 h 39"/>
                <a:gd name="T92" fmla="*/ 9973 w 10329"/>
                <a:gd name="T93" fmla="*/ 0 h 39"/>
                <a:gd name="T94" fmla="*/ 9967 w 10329"/>
                <a:gd name="T95" fmla="*/ 0 h 39"/>
                <a:gd name="T96" fmla="*/ 10329 w 10329"/>
                <a:gd name="T97" fmla="*/ 39 h 39"/>
                <a:gd name="T98" fmla="*/ 10329 w 10329"/>
                <a:gd name="T99" fmla="*/ 0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</a:cxnLst>
              <a:rect l="0" t="0" r="r" b="b"/>
              <a:pathLst>
                <a:path w="10329" h="39">
                  <a:moveTo>
                    <a:pt x="6" y="0"/>
                  </a:moveTo>
                  <a:lnTo>
                    <a:pt x="6" y="39"/>
                  </a:lnTo>
                  <a:lnTo>
                    <a:pt x="0" y="39"/>
                  </a:lnTo>
                  <a:lnTo>
                    <a:pt x="0" y="0"/>
                  </a:lnTo>
                  <a:lnTo>
                    <a:pt x="6" y="0"/>
                  </a:lnTo>
                  <a:close/>
                  <a:moveTo>
                    <a:pt x="361" y="0"/>
                  </a:moveTo>
                  <a:lnTo>
                    <a:pt x="361" y="39"/>
                  </a:lnTo>
                  <a:lnTo>
                    <a:pt x="356" y="39"/>
                  </a:lnTo>
                  <a:lnTo>
                    <a:pt x="356" y="0"/>
                  </a:lnTo>
                  <a:lnTo>
                    <a:pt x="361" y="0"/>
                  </a:lnTo>
                  <a:close/>
                  <a:moveTo>
                    <a:pt x="718" y="0"/>
                  </a:moveTo>
                  <a:lnTo>
                    <a:pt x="718" y="39"/>
                  </a:lnTo>
                  <a:lnTo>
                    <a:pt x="712" y="39"/>
                  </a:lnTo>
                  <a:lnTo>
                    <a:pt x="712" y="0"/>
                  </a:lnTo>
                  <a:lnTo>
                    <a:pt x="718" y="0"/>
                  </a:lnTo>
                  <a:close/>
                  <a:moveTo>
                    <a:pt x="1074" y="0"/>
                  </a:moveTo>
                  <a:lnTo>
                    <a:pt x="1074" y="39"/>
                  </a:lnTo>
                  <a:lnTo>
                    <a:pt x="1068" y="39"/>
                  </a:lnTo>
                  <a:lnTo>
                    <a:pt x="1068" y="0"/>
                  </a:lnTo>
                  <a:lnTo>
                    <a:pt x="1074" y="0"/>
                  </a:lnTo>
                  <a:close/>
                  <a:moveTo>
                    <a:pt x="1430" y="0"/>
                  </a:moveTo>
                  <a:lnTo>
                    <a:pt x="1430" y="39"/>
                  </a:lnTo>
                  <a:lnTo>
                    <a:pt x="1424" y="39"/>
                  </a:lnTo>
                  <a:lnTo>
                    <a:pt x="1424" y="0"/>
                  </a:lnTo>
                  <a:lnTo>
                    <a:pt x="1430" y="0"/>
                  </a:lnTo>
                  <a:close/>
                  <a:moveTo>
                    <a:pt x="1786" y="0"/>
                  </a:moveTo>
                  <a:lnTo>
                    <a:pt x="1786" y="39"/>
                  </a:lnTo>
                  <a:lnTo>
                    <a:pt x="1780" y="39"/>
                  </a:lnTo>
                  <a:lnTo>
                    <a:pt x="1780" y="0"/>
                  </a:lnTo>
                  <a:lnTo>
                    <a:pt x="1786" y="0"/>
                  </a:lnTo>
                  <a:close/>
                  <a:moveTo>
                    <a:pt x="2142" y="0"/>
                  </a:moveTo>
                  <a:lnTo>
                    <a:pt x="2142" y="39"/>
                  </a:lnTo>
                  <a:lnTo>
                    <a:pt x="2136" y="39"/>
                  </a:lnTo>
                  <a:lnTo>
                    <a:pt x="2136" y="0"/>
                  </a:lnTo>
                  <a:lnTo>
                    <a:pt x="2142" y="0"/>
                  </a:lnTo>
                  <a:close/>
                  <a:moveTo>
                    <a:pt x="2497" y="0"/>
                  </a:moveTo>
                  <a:lnTo>
                    <a:pt x="2497" y="39"/>
                  </a:lnTo>
                  <a:lnTo>
                    <a:pt x="2492" y="39"/>
                  </a:lnTo>
                  <a:lnTo>
                    <a:pt x="2492" y="0"/>
                  </a:lnTo>
                  <a:lnTo>
                    <a:pt x="2497" y="0"/>
                  </a:lnTo>
                  <a:close/>
                  <a:moveTo>
                    <a:pt x="2854" y="0"/>
                  </a:moveTo>
                  <a:lnTo>
                    <a:pt x="2854" y="39"/>
                  </a:lnTo>
                  <a:lnTo>
                    <a:pt x="2848" y="39"/>
                  </a:lnTo>
                  <a:lnTo>
                    <a:pt x="2848" y="0"/>
                  </a:lnTo>
                  <a:lnTo>
                    <a:pt x="2854" y="0"/>
                  </a:lnTo>
                  <a:close/>
                  <a:moveTo>
                    <a:pt x="3210" y="0"/>
                  </a:moveTo>
                  <a:lnTo>
                    <a:pt x="3210" y="39"/>
                  </a:lnTo>
                  <a:lnTo>
                    <a:pt x="3204" y="39"/>
                  </a:lnTo>
                  <a:lnTo>
                    <a:pt x="3204" y="0"/>
                  </a:lnTo>
                  <a:lnTo>
                    <a:pt x="3210" y="0"/>
                  </a:lnTo>
                  <a:close/>
                  <a:moveTo>
                    <a:pt x="3566" y="0"/>
                  </a:moveTo>
                  <a:lnTo>
                    <a:pt x="3566" y="39"/>
                  </a:lnTo>
                  <a:lnTo>
                    <a:pt x="3560" y="39"/>
                  </a:lnTo>
                  <a:lnTo>
                    <a:pt x="3560" y="0"/>
                  </a:lnTo>
                  <a:lnTo>
                    <a:pt x="3566" y="0"/>
                  </a:lnTo>
                  <a:close/>
                  <a:moveTo>
                    <a:pt x="3922" y="0"/>
                  </a:moveTo>
                  <a:lnTo>
                    <a:pt x="3922" y="39"/>
                  </a:lnTo>
                  <a:lnTo>
                    <a:pt x="3916" y="39"/>
                  </a:lnTo>
                  <a:lnTo>
                    <a:pt x="3916" y="0"/>
                  </a:lnTo>
                  <a:lnTo>
                    <a:pt x="3922" y="0"/>
                  </a:lnTo>
                  <a:close/>
                  <a:moveTo>
                    <a:pt x="4277" y="0"/>
                  </a:moveTo>
                  <a:lnTo>
                    <a:pt x="4277" y="39"/>
                  </a:lnTo>
                  <a:lnTo>
                    <a:pt x="4271" y="39"/>
                  </a:lnTo>
                  <a:lnTo>
                    <a:pt x="4271" y="0"/>
                  </a:lnTo>
                  <a:lnTo>
                    <a:pt x="4277" y="0"/>
                  </a:lnTo>
                  <a:close/>
                  <a:moveTo>
                    <a:pt x="4633" y="0"/>
                  </a:moveTo>
                  <a:lnTo>
                    <a:pt x="4633" y="39"/>
                  </a:lnTo>
                  <a:lnTo>
                    <a:pt x="4628" y="39"/>
                  </a:lnTo>
                  <a:lnTo>
                    <a:pt x="4628" y="0"/>
                  </a:lnTo>
                  <a:lnTo>
                    <a:pt x="4633" y="0"/>
                  </a:lnTo>
                  <a:close/>
                  <a:moveTo>
                    <a:pt x="4990" y="0"/>
                  </a:moveTo>
                  <a:lnTo>
                    <a:pt x="4990" y="39"/>
                  </a:lnTo>
                  <a:lnTo>
                    <a:pt x="4984" y="39"/>
                  </a:lnTo>
                  <a:lnTo>
                    <a:pt x="4984" y="0"/>
                  </a:lnTo>
                  <a:lnTo>
                    <a:pt x="4990" y="0"/>
                  </a:lnTo>
                  <a:close/>
                  <a:moveTo>
                    <a:pt x="5346" y="0"/>
                  </a:moveTo>
                  <a:lnTo>
                    <a:pt x="5346" y="39"/>
                  </a:lnTo>
                  <a:lnTo>
                    <a:pt x="5340" y="39"/>
                  </a:lnTo>
                  <a:lnTo>
                    <a:pt x="5340" y="0"/>
                  </a:lnTo>
                  <a:lnTo>
                    <a:pt x="5346" y="0"/>
                  </a:lnTo>
                  <a:close/>
                  <a:moveTo>
                    <a:pt x="5702" y="0"/>
                  </a:moveTo>
                  <a:lnTo>
                    <a:pt x="5702" y="39"/>
                  </a:lnTo>
                  <a:lnTo>
                    <a:pt x="5696" y="39"/>
                  </a:lnTo>
                  <a:lnTo>
                    <a:pt x="5696" y="0"/>
                  </a:lnTo>
                  <a:lnTo>
                    <a:pt x="5702" y="0"/>
                  </a:lnTo>
                  <a:close/>
                  <a:moveTo>
                    <a:pt x="6057" y="0"/>
                  </a:moveTo>
                  <a:lnTo>
                    <a:pt x="6057" y="39"/>
                  </a:lnTo>
                  <a:lnTo>
                    <a:pt x="6051" y="39"/>
                  </a:lnTo>
                  <a:lnTo>
                    <a:pt x="6051" y="0"/>
                  </a:lnTo>
                  <a:lnTo>
                    <a:pt x="6057" y="0"/>
                  </a:lnTo>
                  <a:close/>
                  <a:moveTo>
                    <a:pt x="6413" y="0"/>
                  </a:moveTo>
                  <a:lnTo>
                    <a:pt x="6413" y="39"/>
                  </a:lnTo>
                  <a:lnTo>
                    <a:pt x="6407" y="39"/>
                  </a:lnTo>
                  <a:lnTo>
                    <a:pt x="6407" y="0"/>
                  </a:lnTo>
                  <a:lnTo>
                    <a:pt x="6413" y="0"/>
                  </a:lnTo>
                  <a:close/>
                  <a:moveTo>
                    <a:pt x="6769" y="0"/>
                  </a:moveTo>
                  <a:lnTo>
                    <a:pt x="6769" y="39"/>
                  </a:lnTo>
                  <a:lnTo>
                    <a:pt x="6764" y="39"/>
                  </a:lnTo>
                  <a:lnTo>
                    <a:pt x="6764" y="0"/>
                  </a:lnTo>
                  <a:lnTo>
                    <a:pt x="6769" y="0"/>
                  </a:lnTo>
                  <a:close/>
                  <a:moveTo>
                    <a:pt x="7126" y="0"/>
                  </a:moveTo>
                  <a:lnTo>
                    <a:pt x="7126" y="39"/>
                  </a:lnTo>
                  <a:lnTo>
                    <a:pt x="7120" y="39"/>
                  </a:lnTo>
                  <a:lnTo>
                    <a:pt x="7120" y="0"/>
                  </a:lnTo>
                  <a:lnTo>
                    <a:pt x="7126" y="0"/>
                  </a:lnTo>
                  <a:close/>
                  <a:moveTo>
                    <a:pt x="7482" y="0"/>
                  </a:moveTo>
                  <a:lnTo>
                    <a:pt x="7482" y="39"/>
                  </a:lnTo>
                  <a:lnTo>
                    <a:pt x="7476" y="39"/>
                  </a:lnTo>
                  <a:lnTo>
                    <a:pt x="7476" y="0"/>
                  </a:lnTo>
                  <a:lnTo>
                    <a:pt x="7482" y="0"/>
                  </a:lnTo>
                  <a:close/>
                  <a:moveTo>
                    <a:pt x="7838" y="0"/>
                  </a:moveTo>
                  <a:lnTo>
                    <a:pt x="7838" y="39"/>
                  </a:lnTo>
                  <a:lnTo>
                    <a:pt x="7832" y="39"/>
                  </a:lnTo>
                  <a:lnTo>
                    <a:pt x="7832" y="0"/>
                  </a:lnTo>
                  <a:lnTo>
                    <a:pt x="7838" y="0"/>
                  </a:lnTo>
                  <a:close/>
                  <a:moveTo>
                    <a:pt x="8193" y="0"/>
                  </a:moveTo>
                  <a:lnTo>
                    <a:pt x="8193" y="39"/>
                  </a:lnTo>
                  <a:lnTo>
                    <a:pt x="8187" y="39"/>
                  </a:lnTo>
                  <a:lnTo>
                    <a:pt x="8187" y="0"/>
                  </a:lnTo>
                  <a:lnTo>
                    <a:pt x="8193" y="0"/>
                  </a:lnTo>
                  <a:close/>
                  <a:moveTo>
                    <a:pt x="8549" y="0"/>
                  </a:moveTo>
                  <a:lnTo>
                    <a:pt x="8549" y="39"/>
                  </a:lnTo>
                  <a:lnTo>
                    <a:pt x="8543" y="39"/>
                  </a:lnTo>
                  <a:lnTo>
                    <a:pt x="8543" y="0"/>
                  </a:lnTo>
                  <a:lnTo>
                    <a:pt x="8549" y="0"/>
                  </a:lnTo>
                  <a:close/>
                  <a:moveTo>
                    <a:pt x="8905" y="0"/>
                  </a:moveTo>
                  <a:lnTo>
                    <a:pt x="8905" y="39"/>
                  </a:lnTo>
                  <a:lnTo>
                    <a:pt x="8900" y="39"/>
                  </a:lnTo>
                  <a:lnTo>
                    <a:pt x="8900" y="0"/>
                  </a:lnTo>
                  <a:lnTo>
                    <a:pt x="8905" y="0"/>
                  </a:lnTo>
                  <a:close/>
                  <a:moveTo>
                    <a:pt x="9262" y="0"/>
                  </a:moveTo>
                  <a:lnTo>
                    <a:pt x="9262" y="39"/>
                  </a:lnTo>
                  <a:lnTo>
                    <a:pt x="9256" y="39"/>
                  </a:lnTo>
                  <a:lnTo>
                    <a:pt x="9256" y="0"/>
                  </a:lnTo>
                  <a:lnTo>
                    <a:pt x="9262" y="0"/>
                  </a:lnTo>
                  <a:close/>
                  <a:moveTo>
                    <a:pt x="9618" y="0"/>
                  </a:moveTo>
                  <a:lnTo>
                    <a:pt x="9618" y="39"/>
                  </a:lnTo>
                  <a:lnTo>
                    <a:pt x="9612" y="39"/>
                  </a:lnTo>
                  <a:lnTo>
                    <a:pt x="9612" y="0"/>
                  </a:lnTo>
                  <a:lnTo>
                    <a:pt x="9618" y="0"/>
                  </a:lnTo>
                  <a:close/>
                  <a:moveTo>
                    <a:pt x="9973" y="0"/>
                  </a:moveTo>
                  <a:lnTo>
                    <a:pt x="9973" y="39"/>
                  </a:lnTo>
                  <a:lnTo>
                    <a:pt x="9967" y="39"/>
                  </a:lnTo>
                  <a:lnTo>
                    <a:pt x="9967" y="0"/>
                  </a:lnTo>
                  <a:lnTo>
                    <a:pt x="9973" y="0"/>
                  </a:lnTo>
                  <a:close/>
                  <a:moveTo>
                    <a:pt x="10329" y="0"/>
                  </a:moveTo>
                  <a:lnTo>
                    <a:pt x="10329" y="39"/>
                  </a:lnTo>
                  <a:lnTo>
                    <a:pt x="10323" y="39"/>
                  </a:lnTo>
                  <a:lnTo>
                    <a:pt x="10323" y="0"/>
                  </a:lnTo>
                  <a:lnTo>
                    <a:pt x="10329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" name="Rectangle 15"/>
            <p:cNvSpPr>
              <a:spLocks noChangeArrowheads="1"/>
            </p:cNvSpPr>
            <p:nvPr/>
          </p:nvSpPr>
          <p:spPr bwMode="auto">
            <a:xfrm>
              <a:off x="457200" y="1993543"/>
              <a:ext cx="61833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,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Rectangle 16"/>
            <p:cNvSpPr>
              <a:spLocks noChangeArrowheads="1"/>
            </p:cNvSpPr>
            <p:nvPr/>
          </p:nvSpPr>
          <p:spPr bwMode="auto">
            <a:xfrm>
              <a:off x="457200" y="1685354"/>
              <a:ext cx="61833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,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Rectangle 17"/>
            <p:cNvSpPr>
              <a:spLocks noChangeArrowheads="1"/>
            </p:cNvSpPr>
            <p:nvPr/>
          </p:nvSpPr>
          <p:spPr bwMode="auto">
            <a:xfrm>
              <a:off x="457200" y="1378699"/>
              <a:ext cx="61833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3,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Rectangle 18"/>
            <p:cNvSpPr>
              <a:spLocks noChangeArrowheads="1"/>
            </p:cNvSpPr>
            <p:nvPr/>
          </p:nvSpPr>
          <p:spPr bwMode="auto">
            <a:xfrm>
              <a:off x="457200" y="1071277"/>
              <a:ext cx="61833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4,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Rectangle 19"/>
            <p:cNvSpPr>
              <a:spLocks noChangeArrowheads="1"/>
            </p:cNvSpPr>
            <p:nvPr/>
          </p:nvSpPr>
          <p:spPr bwMode="auto">
            <a:xfrm>
              <a:off x="457200" y="764622"/>
              <a:ext cx="61833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5,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Rectangle 20"/>
            <p:cNvSpPr>
              <a:spLocks noChangeArrowheads="1"/>
            </p:cNvSpPr>
            <p:nvPr/>
          </p:nvSpPr>
          <p:spPr bwMode="auto">
            <a:xfrm>
              <a:off x="457200" y="457200"/>
              <a:ext cx="61833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6,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4" name="Group 55"/>
            <p:cNvGrpSpPr/>
            <p:nvPr/>
          </p:nvGrpSpPr>
          <p:grpSpPr>
            <a:xfrm>
              <a:off x="1325335" y="3331008"/>
              <a:ext cx="7309069" cy="844497"/>
              <a:chOff x="1372028" y="2468546"/>
              <a:chExt cx="7228618" cy="928719"/>
            </a:xfrm>
          </p:grpSpPr>
          <p:sp>
            <p:nvSpPr>
              <p:cNvPr id="57" name="Rectangle 799"/>
              <p:cNvSpPr>
                <a:spLocks noChangeArrowheads="1"/>
              </p:cNvSpPr>
              <p:nvPr/>
            </p:nvSpPr>
            <p:spPr bwMode="auto">
              <a:xfrm rot="16200000">
                <a:off x="1011492" y="286931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" name="Rectangle 801"/>
              <p:cNvSpPr>
                <a:spLocks noChangeArrowheads="1"/>
              </p:cNvSpPr>
              <p:nvPr/>
            </p:nvSpPr>
            <p:spPr bwMode="auto">
              <a:xfrm rot="16200000">
                <a:off x="1263907" y="286931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" name="Rectangle 803"/>
              <p:cNvSpPr>
                <a:spLocks noChangeArrowheads="1"/>
              </p:cNvSpPr>
              <p:nvPr/>
            </p:nvSpPr>
            <p:spPr bwMode="auto">
              <a:xfrm rot="16200000">
                <a:off x="1516320" y="2830670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3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" name="Rectangle 805"/>
              <p:cNvSpPr>
                <a:spLocks noChangeArrowheads="1"/>
              </p:cNvSpPr>
              <p:nvPr/>
            </p:nvSpPr>
            <p:spPr bwMode="auto">
              <a:xfrm rot="16200000">
                <a:off x="1770320" y="2830670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4:01</a:t>
                </a:r>
                <a:endParaRPr kumimoji="0" lang="en-US" sz="11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" name="Rectangle 807"/>
              <p:cNvSpPr>
                <a:spLocks noChangeArrowheads="1"/>
              </p:cNvSpPr>
              <p:nvPr/>
            </p:nvSpPr>
            <p:spPr bwMode="auto">
              <a:xfrm rot="16200000">
                <a:off x="2021145" y="2830670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5:01</a:t>
                </a:r>
                <a:endParaRPr kumimoji="0" lang="en-US" sz="11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" name="Rectangle 809"/>
              <p:cNvSpPr>
                <a:spLocks noChangeArrowheads="1"/>
              </p:cNvSpPr>
              <p:nvPr/>
            </p:nvSpPr>
            <p:spPr bwMode="auto">
              <a:xfrm rot="16200000">
                <a:off x="2273559" y="2830670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" name="Rectangle 811"/>
              <p:cNvSpPr>
                <a:spLocks noChangeArrowheads="1"/>
              </p:cNvSpPr>
              <p:nvPr/>
            </p:nvSpPr>
            <p:spPr bwMode="auto">
              <a:xfrm rot="16200000">
                <a:off x="2525969" y="2830670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" name="Rectangle 813"/>
              <p:cNvSpPr>
                <a:spLocks noChangeArrowheads="1"/>
              </p:cNvSpPr>
              <p:nvPr/>
            </p:nvSpPr>
            <p:spPr bwMode="auto">
              <a:xfrm rot="16200000">
                <a:off x="2778382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3:03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5" name="Rectangle 815"/>
              <p:cNvSpPr>
                <a:spLocks noChangeArrowheads="1"/>
              </p:cNvSpPr>
              <p:nvPr/>
            </p:nvSpPr>
            <p:spPr bwMode="auto">
              <a:xfrm rot="16200000">
                <a:off x="3030795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4:01</a:t>
                </a:r>
                <a:endParaRPr kumimoji="0" lang="en-US" sz="11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6" name="Rectangle 817"/>
              <p:cNvSpPr>
                <a:spLocks noChangeArrowheads="1"/>
              </p:cNvSpPr>
              <p:nvPr/>
            </p:nvSpPr>
            <p:spPr bwMode="auto">
              <a:xfrm rot="16200000">
                <a:off x="3281620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1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" name="Rectangle 819"/>
              <p:cNvSpPr>
                <a:spLocks noChangeArrowheads="1"/>
              </p:cNvSpPr>
              <p:nvPr/>
            </p:nvSpPr>
            <p:spPr bwMode="auto">
              <a:xfrm rot="16200000">
                <a:off x="3534032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2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8" name="Rectangle 821"/>
              <p:cNvSpPr>
                <a:spLocks noChangeArrowheads="1"/>
              </p:cNvSpPr>
              <p:nvPr/>
            </p:nvSpPr>
            <p:spPr bwMode="auto">
              <a:xfrm rot="16200000">
                <a:off x="3786446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1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9" name="Rectangle 823"/>
              <p:cNvSpPr>
                <a:spLocks noChangeArrowheads="1"/>
              </p:cNvSpPr>
              <p:nvPr/>
            </p:nvSpPr>
            <p:spPr bwMode="auto">
              <a:xfrm rot="16200000">
                <a:off x="4038860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2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" name="Rectangle 825"/>
              <p:cNvSpPr>
                <a:spLocks noChangeArrowheads="1"/>
              </p:cNvSpPr>
              <p:nvPr/>
            </p:nvSpPr>
            <p:spPr bwMode="auto">
              <a:xfrm rot="16200000">
                <a:off x="4291271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2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1" name="Rectangle 827"/>
              <p:cNvSpPr>
                <a:spLocks noChangeArrowheads="1"/>
              </p:cNvSpPr>
              <p:nvPr/>
            </p:nvSpPr>
            <p:spPr bwMode="auto">
              <a:xfrm rot="16200000">
                <a:off x="4542097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2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2" name="Rectangle 829"/>
              <p:cNvSpPr>
                <a:spLocks noChangeArrowheads="1"/>
              </p:cNvSpPr>
              <p:nvPr/>
            </p:nvSpPr>
            <p:spPr bwMode="auto">
              <a:xfrm rot="16200000">
                <a:off x="4794509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3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3" name="Rectangle 831"/>
              <p:cNvSpPr>
                <a:spLocks noChangeArrowheads="1"/>
              </p:cNvSpPr>
              <p:nvPr/>
            </p:nvSpPr>
            <p:spPr bwMode="auto">
              <a:xfrm rot="16200000">
                <a:off x="5046922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3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4" name="Rectangle 833"/>
              <p:cNvSpPr>
                <a:spLocks noChangeArrowheads="1"/>
              </p:cNvSpPr>
              <p:nvPr/>
            </p:nvSpPr>
            <p:spPr bwMode="auto">
              <a:xfrm rot="16200000">
                <a:off x="5297745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5" name="Rectangle 835"/>
              <p:cNvSpPr>
                <a:spLocks noChangeArrowheads="1"/>
              </p:cNvSpPr>
              <p:nvPr/>
            </p:nvSpPr>
            <p:spPr bwMode="auto">
              <a:xfrm rot="16200000">
                <a:off x="5551745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3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6" name="Rectangle 837"/>
              <p:cNvSpPr>
                <a:spLocks noChangeArrowheads="1"/>
              </p:cNvSpPr>
              <p:nvPr/>
            </p:nvSpPr>
            <p:spPr bwMode="auto">
              <a:xfrm rot="16200000">
                <a:off x="5802571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5:03</a:t>
                </a:r>
                <a:endParaRPr kumimoji="0" lang="en-US" sz="11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" name="Rectangle 839"/>
              <p:cNvSpPr>
                <a:spLocks noChangeArrowheads="1"/>
              </p:cNvSpPr>
              <p:nvPr/>
            </p:nvSpPr>
            <p:spPr bwMode="auto">
              <a:xfrm rot="16200000">
                <a:off x="6054984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5:05</a:t>
                </a:r>
                <a:endParaRPr kumimoji="0" lang="en-US" sz="11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" name="Rectangle 841"/>
              <p:cNvSpPr>
                <a:spLocks noChangeArrowheads="1"/>
              </p:cNvSpPr>
              <p:nvPr/>
            </p:nvSpPr>
            <p:spPr bwMode="auto">
              <a:xfrm rot="16200000">
                <a:off x="6307397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6:01</a:t>
                </a:r>
                <a:endParaRPr kumimoji="0" lang="en-US" sz="11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9" name="Rectangle 843"/>
              <p:cNvSpPr>
                <a:spLocks noChangeArrowheads="1"/>
              </p:cNvSpPr>
              <p:nvPr/>
            </p:nvSpPr>
            <p:spPr bwMode="auto">
              <a:xfrm rot="16200000">
                <a:off x="6559809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1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0" name="Rectangle 845"/>
              <p:cNvSpPr>
                <a:spLocks noChangeArrowheads="1"/>
              </p:cNvSpPr>
              <p:nvPr/>
            </p:nvSpPr>
            <p:spPr bwMode="auto">
              <a:xfrm rot="16200000">
                <a:off x="6812221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1" name="Rectangle 847"/>
              <p:cNvSpPr>
                <a:spLocks noChangeArrowheads="1"/>
              </p:cNvSpPr>
              <p:nvPr/>
            </p:nvSpPr>
            <p:spPr bwMode="auto">
              <a:xfrm rot="16200000">
                <a:off x="7063045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3:01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2" name="Rectangle 849"/>
              <p:cNvSpPr>
                <a:spLocks noChangeArrowheads="1"/>
              </p:cNvSpPr>
              <p:nvPr/>
            </p:nvSpPr>
            <p:spPr bwMode="auto">
              <a:xfrm rot="16200000">
                <a:off x="7315459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3:02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3" name="Rectangle 851"/>
              <p:cNvSpPr>
                <a:spLocks noChangeArrowheads="1"/>
              </p:cNvSpPr>
              <p:nvPr/>
            </p:nvSpPr>
            <p:spPr bwMode="auto">
              <a:xfrm rot="16200000">
                <a:off x="7567869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4" name="Rectangle 853"/>
              <p:cNvSpPr>
                <a:spLocks noChangeArrowheads="1"/>
              </p:cNvSpPr>
              <p:nvPr/>
            </p:nvSpPr>
            <p:spPr bwMode="auto">
              <a:xfrm rot="16200000">
                <a:off x="7820284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3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5" name="Rectangle 855"/>
              <p:cNvSpPr>
                <a:spLocks noChangeArrowheads="1"/>
              </p:cNvSpPr>
              <p:nvPr/>
            </p:nvSpPr>
            <p:spPr bwMode="auto">
              <a:xfrm rot="16200000">
                <a:off x="8072696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3:02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5" name="Group 85"/>
            <p:cNvGrpSpPr/>
            <p:nvPr/>
          </p:nvGrpSpPr>
          <p:grpSpPr>
            <a:xfrm>
              <a:off x="1313502" y="2521881"/>
              <a:ext cx="7307459" cy="809357"/>
              <a:chOff x="1494270" y="2854299"/>
              <a:chExt cx="7227026" cy="890074"/>
            </a:xfrm>
          </p:grpSpPr>
          <p:sp>
            <p:nvSpPr>
              <p:cNvPr id="87" name="Rectangle 800"/>
              <p:cNvSpPr>
                <a:spLocks noChangeArrowheads="1"/>
              </p:cNvSpPr>
              <p:nvPr/>
            </p:nvSpPr>
            <p:spPr bwMode="auto">
              <a:xfrm rot="16200000">
                <a:off x="1133734" y="3216423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8" name="Rectangle 802"/>
              <p:cNvSpPr>
                <a:spLocks noChangeArrowheads="1"/>
              </p:cNvSpPr>
              <p:nvPr/>
            </p:nvSpPr>
            <p:spPr bwMode="auto">
              <a:xfrm rot="16200000">
                <a:off x="1386146" y="321642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2:02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9" name="Rectangle 804"/>
              <p:cNvSpPr>
                <a:spLocks noChangeArrowheads="1"/>
              </p:cNvSpPr>
              <p:nvPr/>
            </p:nvSpPr>
            <p:spPr bwMode="auto">
              <a:xfrm rot="16200000">
                <a:off x="1638560" y="321642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0" name="Rectangle 806"/>
              <p:cNvSpPr>
                <a:spLocks noChangeArrowheads="1"/>
              </p:cNvSpPr>
              <p:nvPr/>
            </p:nvSpPr>
            <p:spPr bwMode="auto">
              <a:xfrm rot="16200000">
                <a:off x="1890970" y="321642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1" name="Rectangle 808"/>
              <p:cNvSpPr>
                <a:spLocks noChangeArrowheads="1"/>
              </p:cNvSpPr>
              <p:nvPr/>
            </p:nvSpPr>
            <p:spPr bwMode="auto">
              <a:xfrm rot="16200000">
                <a:off x="2143384" y="321642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2" name="Rectangle 810"/>
              <p:cNvSpPr>
                <a:spLocks noChangeArrowheads="1"/>
              </p:cNvSpPr>
              <p:nvPr/>
            </p:nvSpPr>
            <p:spPr bwMode="auto">
              <a:xfrm rot="16200000">
                <a:off x="2395794" y="321642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4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" name="Rectangle 812"/>
              <p:cNvSpPr>
                <a:spLocks noChangeArrowheads="1"/>
              </p:cNvSpPr>
              <p:nvPr/>
            </p:nvSpPr>
            <p:spPr bwMode="auto">
              <a:xfrm rot="16200000">
                <a:off x="2648209" y="321483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4:02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4" name="Rectangle 814"/>
              <p:cNvSpPr>
                <a:spLocks noChangeArrowheads="1"/>
              </p:cNvSpPr>
              <p:nvPr/>
            </p:nvSpPr>
            <p:spPr bwMode="auto">
              <a:xfrm rot="16200000">
                <a:off x="2899033" y="321483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4:01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5" name="Rectangle 816"/>
              <p:cNvSpPr>
                <a:spLocks noChangeArrowheads="1"/>
              </p:cNvSpPr>
              <p:nvPr/>
            </p:nvSpPr>
            <p:spPr bwMode="auto">
              <a:xfrm rot="16200000">
                <a:off x="3151446" y="321483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4:02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6" name="Rectangle 818"/>
              <p:cNvSpPr>
                <a:spLocks noChangeArrowheads="1"/>
              </p:cNvSpPr>
              <p:nvPr/>
            </p:nvSpPr>
            <p:spPr bwMode="auto">
              <a:xfrm rot="16200000">
                <a:off x="3403859" y="3214836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5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7" name="Rectangle 820"/>
              <p:cNvSpPr>
                <a:spLocks noChangeArrowheads="1"/>
              </p:cNvSpPr>
              <p:nvPr/>
            </p:nvSpPr>
            <p:spPr bwMode="auto">
              <a:xfrm rot="16200000">
                <a:off x="3656271" y="3214835"/>
                <a:ext cx="888486" cy="167414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5:02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8" name="Rectangle 822"/>
              <p:cNvSpPr>
                <a:spLocks noChangeArrowheads="1"/>
              </p:cNvSpPr>
              <p:nvPr/>
            </p:nvSpPr>
            <p:spPr bwMode="auto">
              <a:xfrm rot="16200000">
                <a:off x="3908684" y="321483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6:02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9" name="Rectangle 824"/>
              <p:cNvSpPr>
                <a:spLocks noChangeArrowheads="1"/>
              </p:cNvSpPr>
              <p:nvPr/>
            </p:nvSpPr>
            <p:spPr bwMode="auto">
              <a:xfrm rot="16200000">
                <a:off x="4159509" y="321483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6:02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0" name="Rectangle 826"/>
              <p:cNvSpPr>
                <a:spLocks noChangeArrowheads="1"/>
              </p:cNvSpPr>
              <p:nvPr/>
            </p:nvSpPr>
            <p:spPr bwMode="auto">
              <a:xfrm rot="16200000">
                <a:off x="4411922" y="321483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6:04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1" name="Rectangle 828"/>
              <p:cNvSpPr>
                <a:spLocks noChangeArrowheads="1"/>
              </p:cNvSpPr>
              <p:nvPr/>
            </p:nvSpPr>
            <p:spPr bwMode="auto">
              <a:xfrm rot="16200000">
                <a:off x="4664333" y="321483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6:09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2" name="Rectangle 830"/>
              <p:cNvSpPr>
                <a:spLocks noChangeArrowheads="1"/>
              </p:cNvSpPr>
              <p:nvPr/>
            </p:nvSpPr>
            <p:spPr bwMode="auto">
              <a:xfrm rot="16200000">
                <a:off x="4916746" y="321483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6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" name="Rectangle 832"/>
              <p:cNvSpPr>
                <a:spLocks noChangeArrowheads="1"/>
              </p:cNvSpPr>
              <p:nvPr/>
            </p:nvSpPr>
            <p:spPr bwMode="auto">
              <a:xfrm rot="16200000">
                <a:off x="5169158" y="321483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6:03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" name="Rectangle 834"/>
              <p:cNvSpPr>
                <a:spLocks noChangeArrowheads="1"/>
              </p:cNvSpPr>
              <p:nvPr/>
            </p:nvSpPr>
            <p:spPr bwMode="auto">
              <a:xfrm rot="16200000">
                <a:off x="5418395" y="321483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3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" name="Rectangle 836"/>
              <p:cNvSpPr>
                <a:spLocks noChangeArrowheads="1"/>
              </p:cNvSpPr>
              <p:nvPr/>
            </p:nvSpPr>
            <p:spPr bwMode="auto">
              <a:xfrm rot="16200000">
                <a:off x="5672395" y="321483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3:01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" name="Rectangle 838"/>
              <p:cNvSpPr>
                <a:spLocks noChangeArrowheads="1"/>
              </p:cNvSpPr>
              <p:nvPr/>
            </p:nvSpPr>
            <p:spPr bwMode="auto">
              <a:xfrm rot="16200000">
                <a:off x="5924809" y="321483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3:01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" name="Rectangle 840"/>
              <p:cNvSpPr>
                <a:spLocks noChangeArrowheads="1"/>
              </p:cNvSpPr>
              <p:nvPr/>
            </p:nvSpPr>
            <p:spPr bwMode="auto">
              <a:xfrm rot="16200000">
                <a:off x="6177220" y="321483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3:01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" name="Rectangle 842"/>
              <p:cNvSpPr>
                <a:spLocks noChangeArrowheads="1"/>
              </p:cNvSpPr>
              <p:nvPr/>
            </p:nvSpPr>
            <p:spPr bwMode="auto">
              <a:xfrm rot="16200000">
                <a:off x="6429633" y="321483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3:01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9" name="Rectangle 844"/>
              <p:cNvSpPr>
                <a:spLocks noChangeArrowheads="1"/>
              </p:cNvSpPr>
              <p:nvPr/>
            </p:nvSpPr>
            <p:spPr bwMode="auto">
              <a:xfrm rot="16200000">
                <a:off x="6680459" y="321483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3:02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0" name="Rectangle 846"/>
              <p:cNvSpPr>
                <a:spLocks noChangeArrowheads="1"/>
              </p:cNvSpPr>
              <p:nvPr/>
            </p:nvSpPr>
            <p:spPr bwMode="auto">
              <a:xfrm rot="16200000">
                <a:off x="6932870" y="321483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3:02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1" name="Rectangle 848"/>
              <p:cNvSpPr>
                <a:spLocks noChangeArrowheads="1"/>
              </p:cNvSpPr>
              <p:nvPr/>
            </p:nvSpPr>
            <p:spPr bwMode="auto">
              <a:xfrm rot="16200000">
                <a:off x="7185284" y="321483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3:02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2" name="Rectangle 850"/>
              <p:cNvSpPr>
                <a:spLocks noChangeArrowheads="1"/>
              </p:cNvSpPr>
              <p:nvPr/>
            </p:nvSpPr>
            <p:spPr bwMode="auto">
              <a:xfrm rot="16200000">
                <a:off x="7437695" y="321483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3:02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3" name="Rectangle 852"/>
              <p:cNvSpPr>
                <a:spLocks noChangeArrowheads="1"/>
              </p:cNvSpPr>
              <p:nvPr/>
            </p:nvSpPr>
            <p:spPr bwMode="auto">
              <a:xfrm rot="16200000">
                <a:off x="7690108" y="321483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3:03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4" name="Rectangle 854"/>
              <p:cNvSpPr>
                <a:spLocks noChangeArrowheads="1"/>
              </p:cNvSpPr>
              <p:nvPr/>
            </p:nvSpPr>
            <p:spPr bwMode="auto">
              <a:xfrm rot="16200000">
                <a:off x="7940932" y="321483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3:03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5" name="Rectangle 856"/>
              <p:cNvSpPr>
                <a:spLocks noChangeArrowheads="1"/>
              </p:cNvSpPr>
              <p:nvPr/>
            </p:nvSpPr>
            <p:spPr bwMode="auto">
              <a:xfrm rot="16200000">
                <a:off x="8193346" y="3214835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3:03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16" name="TextBox 115"/>
            <p:cNvSpPr txBox="1"/>
            <p:nvPr/>
          </p:nvSpPr>
          <p:spPr>
            <a:xfrm>
              <a:off x="710332" y="2677562"/>
              <a:ext cx="55015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Beta</a:t>
              </a:r>
            </a:p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chain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685800" y="3447644"/>
              <a:ext cx="57579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Alpha</a:t>
              </a:r>
            </a:p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chain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3049637" y="4175505"/>
              <a:ext cx="31092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HLA DQ Single Antigen beads specificities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19" name="Straight Connector 118"/>
            <p:cNvCxnSpPr/>
            <p:nvPr/>
          </p:nvCxnSpPr>
          <p:spPr>
            <a:xfrm>
              <a:off x="228600" y="4426881"/>
              <a:ext cx="8610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1" name="Rectangle 190"/>
            <p:cNvSpPr>
              <a:spLocks noChangeArrowheads="1"/>
            </p:cNvSpPr>
            <p:nvPr/>
          </p:nvSpPr>
          <p:spPr bwMode="auto">
            <a:xfrm>
              <a:off x="2338086" y="279898"/>
              <a:ext cx="459693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QA </a:t>
              </a:r>
              <a:r>
                <a:rPr kumimoji="0" lang="en-US" sz="1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epitope</a:t>
              </a:r>
              <a:r>
                <a:rPr kumimoji="0" lang="en-US" sz="1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on DQA4,5,6 chains</a:t>
              </a:r>
              <a:endPara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2" name="Rectangle 121"/>
            <p:cNvSpPr/>
            <p:nvPr/>
          </p:nvSpPr>
          <p:spPr>
            <a:xfrm>
              <a:off x="228600" y="152400"/>
              <a:ext cx="8610600" cy="6477000"/>
            </a:xfrm>
            <a:prstGeom prst="rect">
              <a:avLst/>
            </a:prstGeom>
            <a:noFill/>
            <a:ln w="952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23" name="Rectangle 122"/>
            <p:cNvSpPr/>
            <p:nvPr/>
          </p:nvSpPr>
          <p:spPr>
            <a:xfrm>
              <a:off x="7086600" y="304800"/>
              <a:ext cx="148790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 err="1" smtClean="0">
                  <a:latin typeface="Arial" pitchFamily="34" charset="0"/>
                  <a:cs typeface="Arial" pitchFamily="34" charset="0"/>
                </a:rPr>
                <a:t>Unadsorbed</a:t>
              </a:r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 serum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6" name="Group 124"/>
            <p:cNvGrpSpPr/>
            <p:nvPr/>
          </p:nvGrpSpPr>
          <p:grpSpPr>
            <a:xfrm>
              <a:off x="5869084" y="4540470"/>
              <a:ext cx="1446116" cy="1936530"/>
              <a:chOff x="6859684" y="4468035"/>
              <a:chExt cx="1446116" cy="1936530"/>
            </a:xfrm>
          </p:grpSpPr>
          <p:pic>
            <p:nvPicPr>
              <p:cNvPr id="32" name="Picture 31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 l="33885" t="17195" r="37184"/>
              <a:stretch/>
            </p:blipFill>
            <p:spPr>
              <a:xfrm>
                <a:off x="6859684" y="4468035"/>
                <a:ext cx="1446116" cy="193653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30" name="TextBox 129"/>
              <p:cNvSpPr txBox="1"/>
              <p:nvPr/>
            </p:nvSpPr>
            <p:spPr>
              <a:xfrm>
                <a:off x="7010400" y="5486400"/>
                <a:ext cx="575800" cy="46166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Alpha</a:t>
                </a:r>
              </a:p>
              <a:p>
                <a:pPr algn="ctr"/>
                <a:r>
                  <a:rPr lang="en-US" sz="12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chain</a:t>
                </a:r>
                <a:endParaRPr lang="en-US" sz="12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1" name="TextBox 130"/>
              <p:cNvSpPr txBox="1"/>
              <p:nvPr/>
            </p:nvSpPr>
            <p:spPr>
              <a:xfrm>
                <a:off x="7543800" y="5638800"/>
                <a:ext cx="550152" cy="46166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Beta</a:t>
                </a:r>
              </a:p>
              <a:p>
                <a:pPr algn="ctr"/>
                <a:r>
                  <a:rPr lang="en-US" sz="12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chain</a:t>
                </a:r>
                <a:endParaRPr lang="en-US" sz="12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2" name="TextBox 131"/>
              <p:cNvSpPr txBox="1"/>
              <p:nvPr/>
            </p:nvSpPr>
            <p:spPr>
              <a:xfrm rot="4628673">
                <a:off x="7259786" y="4848698"/>
                <a:ext cx="744994" cy="26161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Peptide</a:t>
                </a:r>
                <a:endParaRPr lang="en-US" sz="1100" b="1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3" name="TextBox 132"/>
              <p:cNvSpPr txBox="1"/>
              <p:nvPr/>
            </p:nvSpPr>
            <p:spPr>
              <a:xfrm>
                <a:off x="7010400" y="4953000"/>
                <a:ext cx="4748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53Q</a:t>
                </a:r>
                <a:endParaRPr lang="en-US" sz="1200" b="1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pic>
          <p:nvPicPr>
            <p:cNvPr id="7221" name="Picture 53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28800" y="4506629"/>
              <a:ext cx="3618802" cy="185934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26" name="TextBox 125"/>
            <p:cNvSpPr txBox="1"/>
            <p:nvPr/>
          </p:nvSpPr>
          <p:spPr>
            <a:xfrm rot="16200000">
              <a:off x="-890792" y="1300368"/>
              <a:ext cx="24513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Fluorescence Intensity (MFI)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073" name="Rectangle 1"/>
          <p:cNvSpPr>
            <a:spLocks noChangeArrowheads="1"/>
          </p:cNvSpPr>
          <p:nvPr/>
        </p:nvSpPr>
        <p:spPr bwMode="auto">
          <a:xfrm>
            <a:off x="0" y="-33010"/>
            <a:ext cx="9144000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Figure J.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Epitope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2018 shared by the alpha chains of the DQ4, 5, 6 antigens and defined by Glutamine (Q) at position 53.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35221884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28</Words>
  <Application>Microsoft Office PowerPoint</Application>
  <PresentationFormat>On-screen Show (4:3)</PresentationFormat>
  <Paragraphs>8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adim</dc:creator>
  <cp:lastModifiedBy>Nadim</cp:lastModifiedBy>
  <cp:revision>1</cp:revision>
  <dcterms:created xsi:type="dcterms:W3CDTF">2017-03-12T04:20:39Z</dcterms:created>
  <dcterms:modified xsi:type="dcterms:W3CDTF">2017-03-12T04:22:10Z</dcterms:modified>
</cp:coreProperties>
</file>